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1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8310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2456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4125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1760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4276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2202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951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4067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8150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0572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6418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7052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6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png"/><Relationship Id="rId4" Type="http://schemas.openxmlformats.org/officeDocument/2006/relationships/image" Target="../media/image1.emf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78">
            <a:extLst>
              <a:ext uri="{FF2B5EF4-FFF2-40B4-BE49-F238E27FC236}">
                <a16:creationId xmlns:a16="http://schemas.microsoft.com/office/drawing/2014/main" id="{5C50DC8A-5E6D-6B26-E880-08C5C91B27E8}"/>
              </a:ext>
            </a:extLst>
          </p:cNvPr>
          <p:cNvSpPr txBox="1"/>
          <p:nvPr/>
        </p:nvSpPr>
        <p:spPr>
          <a:xfrm>
            <a:off x="290097" y="55886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10" name="Objeto 26">
            <a:extLst>
              <a:ext uri="{FF2B5EF4-FFF2-40B4-BE49-F238E27FC236}">
                <a16:creationId xmlns:a16="http://schemas.microsoft.com/office/drawing/2014/main" id="{98ACF1BF-7A51-2C11-FFF0-788F2FB9237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96391" y="862816"/>
          <a:ext cx="1657350" cy="2108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10" r:id="rId3" imgW="1657345" imgH="2108702" progId="Prism10.Document">
                  <p:embed/>
                </p:oleObj>
              </mc:Choice>
              <mc:Fallback>
                <p:oleObj name="Prism 10" r:id="rId3" imgW="1657345" imgH="2108702" progId="Prism10.Document">
                  <p:embed/>
                  <p:pic>
                    <p:nvPicPr>
                      <p:cNvPr id="10" name="Objeto 26">
                        <a:extLst>
                          <a:ext uri="{FF2B5EF4-FFF2-40B4-BE49-F238E27FC236}">
                            <a16:creationId xmlns:a16="http://schemas.microsoft.com/office/drawing/2014/main" id="{98ACF1BF-7A51-2C11-FFF0-788F2FB923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6391" y="862816"/>
                        <a:ext cx="1657350" cy="2108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to 27">
            <a:extLst>
              <a:ext uri="{FF2B5EF4-FFF2-40B4-BE49-F238E27FC236}">
                <a16:creationId xmlns:a16="http://schemas.microsoft.com/office/drawing/2014/main" id="{24084A1A-6F03-C6D0-45A0-846A7274272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242342" y="881398"/>
          <a:ext cx="1728787" cy="2036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Prism 10" r:id="rId5" imgW="1729012" imgH="2037031" progId="Prism10.Document">
                  <p:embed/>
                </p:oleObj>
              </mc:Choice>
              <mc:Fallback>
                <p:oleObj name="Prism 10" r:id="rId5" imgW="1729012" imgH="2037031" progId="Prism10.Document">
                  <p:embed/>
                  <p:pic>
                    <p:nvPicPr>
                      <p:cNvPr id="11" name="Objeto 27">
                        <a:extLst>
                          <a:ext uri="{FF2B5EF4-FFF2-40B4-BE49-F238E27FC236}">
                            <a16:creationId xmlns:a16="http://schemas.microsoft.com/office/drawing/2014/main" id="{24084A1A-6F03-C6D0-45A0-846A727427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42342" y="881398"/>
                        <a:ext cx="1728787" cy="2036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CuadroTexto 28">
            <a:extLst>
              <a:ext uri="{FF2B5EF4-FFF2-40B4-BE49-F238E27FC236}">
                <a16:creationId xmlns:a16="http://schemas.microsoft.com/office/drawing/2014/main" id="{B5B5E8F7-FF32-14EE-7B92-147A49FA0B0A}"/>
              </a:ext>
            </a:extLst>
          </p:cNvPr>
          <p:cNvSpPr txBox="1"/>
          <p:nvPr/>
        </p:nvSpPr>
        <p:spPr>
          <a:xfrm>
            <a:off x="1240973" y="74980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TCGA</a:t>
            </a:r>
          </a:p>
        </p:txBody>
      </p:sp>
      <p:sp>
        <p:nvSpPr>
          <p:cNvPr id="13" name="CuadroTexto 29">
            <a:extLst>
              <a:ext uri="{FF2B5EF4-FFF2-40B4-BE49-F238E27FC236}">
                <a16:creationId xmlns:a16="http://schemas.microsoft.com/office/drawing/2014/main" id="{D979AB4F-1C09-D00D-B6E3-4F349AD52598}"/>
              </a:ext>
            </a:extLst>
          </p:cNvPr>
          <p:cNvSpPr txBox="1"/>
          <p:nvPr/>
        </p:nvSpPr>
        <p:spPr>
          <a:xfrm>
            <a:off x="3020868" y="74980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Taylor</a:t>
            </a:r>
          </a:p>
        </p:txBody>
      </p:sp>
      <p:graphicFrame>
        <p:nvGraphicFramePr>
          <p:cNvPr id="14" name="Objeto 30">
            <a:extLst>
              <a:ext uri="{FF2B5EF4-FFF2-40B4-BE49-F238E27FC236}">
                <a16:creationId xmlns:a16="http://schemas.microsoft.com/office/drawing/2014/main" id="{3FFAF3B4-727F-151E-0557-DF58C92E9FB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199627" y="879976"/>
          <a:ext cx="1711325" cy="2036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10" r:id="rId7" imgW="1712085" imgH="2037031" progId="Prism10.Document">
                  <p:embed/>
                </p:oleObj>
              </mc:Choice>
              <mc:Fallback>
                <p:oleObj name="Prism 10" r:id="rId7" imgW="1712085" imgH="2037031" progId="Prism10.Document">
                  <p:embed/>
                  <p:pic>
                    <p:nvPicPr>
                      <p:cNvPr id="14" name="Objeto 30">
                        <a:extLst>
                          <a:ext uri="{FF2B5EF4-FFF2-40B4-BE49-F238E27FC236}">
                            <a16:creationId xmlns:a16="http://schemas.microsoft.com/office/drawing/2014/main" id="{3FFAF3B4-727F-151E-0557-DF58C92E9FB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99627" y="879976"/>
                        <a:ext cx="1711325" cy="2036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CuadroTexto 31">
            <a:extLst>
              <a:ext uri="{FF2B5EF4-FFF2-40B4-BE49-F238E27FC236}">
                <a16:creationId xmlns:a16="http://schemas.microsoft.com/office/drawing/2014/main" id="{C25C9856-DE2B-91B0-8D19-53F70F47ED2E}"/>
              </a:ext>
            </a:extLst>
          </p:cNvPr>
          <p:cNvSpPr txBox="1"/>
          <p:nvPr/>
        </p:nvSpPr>
        <p:spPr>
          <a:xfrm>
            <a:off x="4973406" y="749803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Grasso</a:t>
            </a:r>
          </a:p>
        </p:txBody>
      </p:sp>
      <p:pic>
        <p:nvPicPr>
          <p:cNvPr id="17" name="Imagen 16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3B0F289A-C8A7-00CD-6163-DD6617D58DB2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34" t="22120" b="6006"/>
          <a:stretch/>
        </p:blipFill>
        <p:spPr>
          <a:xfrm>
            <a:off x="3590924" y="5746084"/>
            <a:ext cx="1887645" cy="1428614"/>
          </a:xfrm>
          <a:prstGeom prst="rect">
            <a:avLst/>
          </a:prstGeom>
        </p:spPr>
      </p:pic>
      <p:pic>
        <p:nvPicPr>
          <p:cNvPr id="19" name="Imagen 18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6C4CB06D-890E-DD40-D0A1-B49DDF9D536D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8" t="22015" b="5354"/>
          <a:stretch/>
        </p:blipFill>
        <p:spPr>
          <a:xfrm>
            <a:off x="3586705" y="3640112"/>
            <a:ext cx="1878758" cy="1440000"/>
          </a:xfrm>
          <a:prstGeom prst="rect">
            <a:avLst/>
          </a:prstGeom>
        </p:spPr>
      </p:pic>
      <p:pic>
        <p:nvPicPr>
          <p:cNvPr id="20" name="Imagen 19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79DDE51C-D1CF-75D3-2F87-3D4814FD399E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3" t="22015" b="5915"/>
          <a:stretch/>
        </p:blipFill>
        <p:spPr>
          <a:xfrm>
            <a:off x="1240973" y="3640112"/>
            <a:ext cx="1851403" cy="1404000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F488A5AD-60F8-5B89-4A47-250542FE411D}"/>
              </a:ext>
            </a:extLst>
          </p:cNvPr>
          <p:cNvSpPr txBox="1"/>
          <p:nvPr/>
        </p:nvSpPr>
        <p:spPr>
          <a:xfrm>
            <a:off x="4087685" y="5394342"/>
            <a:ext cx="8707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Glinsky</a:t>
            </a:r>
            <a:endParaRPr lang="es-E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Rho/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-0.3737606</a:t>
            </a:r>
          </a:p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p.v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0.00212632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68C9F672-DB43-C55A-5D71-DAA19BEF6FA2}"/>
              </a:ext>
            </a:extLst>
          </p:cNvPr>
          <p:cNvSpPr txBox="1"/>
          <p:nvPr/>
        </p:nvSpPr>
        <p:spPr>
          <a:xfrm>
            <a:off x="1725327" y="5394342"/>
            <a:ext cx="8707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Grasso</a:t>
            </a: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Rho/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-0.5718367</a:t>
            </a:r>
          </a:p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p.v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2.505e-05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94F844B4-4536-AA73-BB49-7D619A245965}"/>
              </a:ext>
            </a:extLst>
          </p:cNvPr>
          <p:cNvSpPr txBox="1"/>
          <p:nvPr/>
        </p:nvSpPr>
        <p:spPr>
          <a:xfrm>
            <a:off x="4169170" y="3232725"/>
            <a:ext cx="7841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Taylor</a:t>
            </a: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Rho/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-0.35022</a:t>
            </a:r>
          </a:p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p.v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4.602e-05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93661FBA-FAE0-3F35-B6ED-9FE4BD83C325}"/>
              </a:ext>
            </a:extLst>
          </p:cNvPr>
          <p:cNvSpPr txBox="1"/>
          <p:nvPr/>
        </p:nvSpPr>
        <p:spPr>
          <a:xfrm>
            <a:off x="1761646" y="3232725"/>
            <a:ext cx="7841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TCGA</a:t>
            </a: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Rho/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-0.40587</a:t>
            </a:r>
          </a:p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p.v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&lt; 2.2e-16</a:t>
            </a:r>
          </a:p>
        </p:txBody>
      </p:sp>
      <p:sp>
        <p:nvSpPr>
          <p:cNvPr id="25" name="TextBox 78">
            <a:extLst>
              <a:ext uri="{FF2B5EF4-FFF2-40B4-BE49-F238E27FC236}">
                <a16:creationId xmlns:a16="http://schemas.microsoft.com/office/drawing/2014/main" id="{5C50DC8A-5E6D-6B26-E880-08C5C91B27E8}"/>
              </a:ext>
            </a:extLst>
          </p:cNvPr>
          <p:cNvSpPr txBox="1"/>
          <p:nvPr/>
        </p:nvSpPr>
        <p:spPr>
          <a:xfrm>
            <a:off x="714113" y="31552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7" name="Imagen 33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A490A7C6-3A8F-3493-8026-9903A11B2608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7" t="22121" b="6006"/>
          <a:stretch/>
        </p:blipFill>
        <p:spPr>
          <a:xfrm>
            <a:off x="1165860" y="5746084"/>
            <a:ext cx="1876251" cy="1428614"/>
          </a:xfrm>
          <a:prstGeom prst="rect">
            <a:avLst/>
          </a:prstGeom>
        </p:spPr>
      </p:pic>
      <p:sp>
        <p:nvSpPr>
          <p:cNvPr id="30" name="CuadroTexto 29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 rot="16200000">
            <a:off x="438705" y="4155110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signatur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>
            <a:off x="1687164" y="5045929"/>
            <a:ext cx="8964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 rot="16200000">
            <a:off x="2848362" y="4155111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signatur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>
            <a:off x="4077884" y="5045929"/>
            <a:ext cx="8964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 rot="16200000">
            <a:off x="414591" y="6207769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signatur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>
            <a:off x="1669888" y="7151643"/>
            <a:ext cx="8964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 rot="16200000">
            <a:off x="2854337" y="6231231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signatur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>
            <a:off x="4077884" y="7156055"/>
            <a:ext cx="8964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</a:p>
        </p:txBody>
      </p:sp>
    </p:spTree>
    <p:extLst>
      <p:ext uri="{BB962C8B-B14F-4D97-AF65-F5344CB8AC3E}">
        <p14:creationId xmlns:p14="http://schemas.microsoft.com/office/powerpoint/2010/main" val="19787032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E08F96959341DC44ACC07BE7930747C5" ma:contentTypeVersion="16" ma:contentTypeDescription="Crear nuevo documento." ma:contentTypeScope="" ma:versionID="2eaba2a1d388e081d2d0f94468dad096">
  <xsd:schema xmlns:xsd="http://www.w3.org/2001/XMLSchema" xmlns:xs="http://www.w3.org/2001/XMLSchema" xmlns:p="http://schemas.microsoft.com/office/2006/metadata/properties" xmlns:ns3="8b32a2f3-31cc-4627-876f-bbb3bae2533e" xmlns:ns4="24ccf71b-f436-409d-8863-79d1e6494e04" targetNamespace="http://schemas.microsoft.com/office/2006/metadata/properties" ma:root="true" ma:fieldsID="6738a71c16d081722b1ed99a2c8802fb" ns3:_="" ns4:_="">
    <xsd:import namespace="8b32a2f3-31cc-4627-876f-bbb3bae2533e"/>
    <xsd:import namespace="24ccf71b-f436-409d-8863-79d1e6494e0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_activity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Location" minOccurs="0"/>
                <xsd:element ref="ns3:MediaServiceSystemTags" minOccurs="0"/>
                <xsd:element ref="ns3:MediaServiceSearchPropertie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32a2f3-31cc-4627-876f-bbb3bae2533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1" nillable="true" ma:displayName="_activity" ma:hidden="true" ma:internalName="_activity">
      <xsd:simpleType>
        <xsd:restriction base="dms:Note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8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4ccf71b-f436-409d-8863-79d1e6494e04" elementFormDefault="qualified">
    <xsd:import namespace="http://schemas.microsoft.com/office/2006/documentManagement/types"/>
    <xsd:import namespace="http://schemas.microsoft.com/office/infopath/2007/PartnerControls"/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3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b32a2f3-31cc-4627-876f-bbb3bae2533e" xsi:nil="true"/>
  </documentManagement>
</p:properties>
</file>

<file path=customXml/itemProps1.xml><?xml version="1.0" encoding="utf-8"?>
<ds:datastoreItem xmlns:ds="http://schemas.openxmlformats.org/officeDocument/2006/customXml" ds:itemID="{5520226C-EA18-4A77-A902-19CE3A5A64A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32a2f3-31cc-4627-876f-bbb3bae2533e"/>
    <ds:schemaRef ds:uri="24ccf71b-f436-409d-8863-79d1e6494e0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34C93E9-3139-4711-98AD-D36D6ACB18B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B66D31B-72AD-4EA6-AF35-C29F36339492}">
  <ds:schemaRefs>
    <ds:schemaRef ds:uri="8b32a2f3-31cc-4627-876f-bbb3bae2533e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purl.org/dc/terms/"/>
    <ds:schemaRef ds:uri="http://schemas.microsoft.com/office/infopath/2007/PartnerControls"/>
    <ds:schemaRef ds:uri="http://schemas.microsoft.com/office/2006/documentManagement/types"/>
    <ds:schemaRef ds:uri="24ccf71b-f436-409d-8863-79d1e6494e04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81</Words>
  <Application>Microsoft Office PowerPoint</Application>
  <PresentationFormat>A4 (210 x 297 mm)</PresentationFormat>
  <Paragraphs>29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10</vt:lpstr>
      <vt:lpstr>Presentación de PowerPoint</vt:lpstr>
    </vt:vector>
  </TitlesOfParts>
  <Company>UPV/EH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eronica TORRANO</dc:creator>
  <cp:lastModifiedBy>VERONICA TORRANO MOYA</cp:lastModifiedBy>
  <cp:revision>5</cp:revision>
  <dcterms:created xsi:type="dcterms:W3CDTF">2025-04-03T06:39:25Z</dcterms:created>
  <dcterms:modified xsi:type="dcterms:W3CDTF">2025-04-03T06:42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8F96959341DC44ACC07BE7930747C5</vt:lpwstr>
  </property>
</Properties>
</file>